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60" r:id="rId2"/>
    <p:sldId id="261" r:id="rId3"/>
    <p:sldId id="259" r:id="rId4"/>
    <p:sldId id="262" r:id="rId5"/>
    <p:sldId id="265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8" userDrawn="1">
          <p15:clr>
            <a:srgbClr val="A4A3A4"/>
          </p15:clr>
        </p15:guide>
        <p15:guide id="2" pos="232" userDrawn="1">
          <p15:clr>
            <a:srgbClr val="A4A3A4"/>
          </p15:clr>
        </p15:guide>
        <p15:guide id="3" orient="horz" pos="1033" userDrawn="1">
          <p15:clr>
            <a:srgbClr val="A4A3A4"/>
          </p15:clr>
        </p15:guide>
        <p15:guide id="4" orient="horz" pos="2077" userDrawn="1">
          <p15:clr>
            <a:srgbClr val="A4A3A4"/>
          </p15:clr>
        </p15:guide>
        <p15:guide id="5" orient="horz" pos="3075" userDrawn="1">
          <p15:clr>
            <a:srgbClr val="A4A3A4"/>
          </p15:clr>
        </p15:guide>
        <p15:guide id="6" pos="41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F6F6F6"/>
    <a:srgbClr val="383130"/>
    <a:srgbClr val="230C0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1F9E764-7024-B741-8C15-E26ECB229BA0}" v="54" dt="2024-03-06T10:54:31.4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242"/>
    <p:restoredTop sz="95014"/>
  </p:normalViewPr>
  <p:slideViewPr>
    <p:cSldViewPr snapToGrid="0">
      <p:cViewPr>
        <p:scale>
          <a:sx n="160" d="100"/>
          <a:sy n="160" d="100"/>
        </p:scale>
        <p:origin x="1104" y="-4704"/>
      </p:cViewPr>
      <p:guideLst>
        <p:guide orient="horz" pos="398"/>
        <p:guide pos="232"/>
        <p:guide orient="horz" pos="1033"/>
        <p:guide orient="horz" pos="2077"/>
        <p:guide orient="horz" pos="3075"/>
        <p:guide pos="41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 To" userId="afe99e57b70de78c" providerId="LiveId" clId="{36E1FBA9-6834-864D-ADD0-F743F3B655D0}"/>
    <pc:docChg chg="undo custSel addSld modSld sldOrd">
      <pc:chgData name="Alex To" userId="afe99e57b70de78c" providerId="LiveId" clId="{36E1FBA9-6834-864D-ADD0-F743F3B655D0}" dt="2024-01-31T12:27:18.286" v="123" actId="1038"/>
      <pc:docMkLst>
        <pc:docMk/>
      </pc:docMkLst>
      <pc:sldChg chg="addSp modSp mod ord">
        <pc:chgData name="Alex To" userId="afe99e57b70de78c" providerId="LiveId" clId="{36E1FBA9-6834-864D-ADD0-F743F3B655D0}" dt="2024-01-31T12:27:18.286" v="123" actId="1038"/>
        <pc:sldMkLst>
          <pc:docMk/>
          <pc:sldMk cId="1615469792" sldId="259"/>
        </pc:sldMkLst>
        <pc:spChg chg="mod">
          <ac:chgData name="Alex To" userId="afe99e57b70de78c" providerId="LiveId" clId="{36E1FBA9-6834-864D-ADD0-F743F3B655D0}" dt="2024-01-31T12:26:08.625" v="101" actId="1036"/>
          <ac:spMkLst>
            <pc:docMk/>
            <pc:sldMk cId="1615469792" sldId="259"/>
            <ac:spMk id="2" creationId="{A3D3C0F6-3862-5A62-F7C7-AD6499CE11A0}"/>
          </ac:spMkLst>
        </pc:spChg>
        <pc:spChg chg="add mod">
          <ac:chgData name="Alex To" userId="afe99e57b70de78c" providerId="LiveId" clId="{36E1FBA9-6834-864D-ADD0-F743F3B655D0}" dt="2024-01-31T12:26:19.395" v="103" actId="1076"/>
          <ac:spMkLst>
            <pc:docMk/>
            <pc:sldMk cId="1615469792" sldId="259"/>
            <ac:spMk id="3" creationId="{1FCB92AB-60D1-7F4D-5419-C7041F6D5721}"/>
          </ac:spMkLst>
        </pc:spChg>
        <pc:spChg chg="add mod">
          <ac:chgData name="Alex To" userId="afe99e57b70de78c" providerId="LiveId" clId="{36E1FBA9-6834-864D-ADD0-F743F3B655D0}" dt="2024-01-31T12:27:15.983" v="120" actId="1037"/>
          <ac:spMkLst>
            <pc:docMk/>
            <pc:sldMk cId="1615469792" sldId="259"/>
            <ac:spMk id="5" creationId="{5E2298F5-FC6F-13F0-39CF-FAC84099F52C}"/>
          </ac:spMkLst>
        </pc:spChg>
        <pc:spChg chg="mod">
          <ac:chgData name="Alex To" userId="afe99e57b70de78c" providerId="LiveId" clId="{36E1FBA9-6834-864D-ADD0-F743F3B655D0}" dt="2024-01-31T12:26:08.625" v="101" actId="1036"/>
          <ac:spMkLst>
            <pc:docMk/>
            <pc:sldMk cId="1615469792" sldId="259"/>
            <ac:spMk id="6" creationId="{62582D61-C16A-4DCE-FD55-A9B99B6FF78B}"/>
          </ac:spMkLst>
        </pc:spChg>
        <pc:spChg chg="mod">
          <ac:chgData name="Alex To" userId="afe99e57b70de78c" providerId="LiveId" clId="{36E1FBA9-6834-864D-ADD0-F743F3B655D0}" dt="2024-01-31T12:27:18.286" v="123" actId="1038"/>
          <ac:spMkLst>
            <pc:docMk/>
            <pc:sldMk cId="1615469792" sldId="259"/>
            <ac:spMk id="7" creationId="{296B8522-7A62-6D8F-2F5D-D1B085361FAC}"/>
          </ac:spMkLst>
        </pc:spChg>
        <pc:spChg chg="mod">
          <ac:chgData name="Alex To" userId="afe99e57b70de78c" providerId="LiveId" clId="{36E1FBA9-6834-864D-ADD0-F743F3B655D0}" dt="2024-01-31T12:26:08.625" v="101" actId="1036"/>
          <ac:spMkLst>
            <pc:docMk/>
            <pc:sldMk cId="1615469792" sldId="259"/>
            <ac:spMk id="9" creationId="{C1C1AFE5-0226-3391-4591-CCC7D9FFAB9E}"/>
          </ac:spMkLst>
        </pc:spChg>
        <pc:picChg chg="mod">
          <ac:chgData name="Alex To" userId="afe99e57b70de78c" providerId="LiveId" clId="{36E1FBA9-6834-864D-ADD0-F743F3B655D0}" dt="2024-01-31T12:26:08.625" v="101" actId="1036"/>
          <ac:picMkLst>
            <pc:docMk/>
            <pc:sldMk cId="1615469792" sldId="259"/>
            <ac:picMk id="4" creationId="{CE11660C-71C9-65E2-9717-056A8467947F}"/>
          </ac:picMkLst>
        </pc:picChg>
        <pc:picChg chg="mod">
          <ac:chgData name="Alex To" userId="afe99e57b70de78c" providerId="LiveId" clId="{36E1FBA9-6834-864D-ADD0-F743F3B655D0}" dt="2024-01-31T12:27:10.526" v="118" actId="1076"/>
          <ac:picMkLst>
            <pc:docMk/>
            <pc:sldMk cId="1615469792" sldId="259"/>
            <ac:picMk id="8" creationId="{CC5BC97A-7AA4-84A9-C702-D06A1F1E0DB7}"/>
          </ac:picMkLst>
        </pc:picChg>
      </pc:sldChg>
      <pc:sldChg chg="addSp modSp new mod ord">
        <pc:chgData name="Alex To" userId="afe99e57b70de78c" providerId="LiveId" clId="{36E1FBA9-6834-864D-ADD0-F743F3B655D0}" dt="2024-01-31T12:25:12.940" v="43" actId="1076"/>
        <pc:sldMkLst>
          <pc:docMk/>
          <pc:sldMk cId="1770989470" sldId="260"/>
        </pc:sldMkLst>
        <pc:spChg chg="add mod">
          <ac:chgData name="Alex To" userId="afe99e57b70de78c" providerId="LiveId" clId="{36E1FBA9-6834-864D-ADD0-F743F3B655D0}" dt="2024-01-31T12:25:12.940" v="43" actId="1076"/>
          <ac:spMkLst>
            <pc:docMk/>
            <pc:sldMk cId="1770989470" sldId="260"/>
            <ac:spMk id="2" creationId="{6EBFA019-DDA6-2EB6-D40D-B8011CC984C1}"/>
          </ac:spMkLst>
        </pc:spChg>
      </pc:sldChg>
    </pc:docChg>
  </pc:docChgLst>
  <pc:docChgLst>
    <pc:chgData name="Alex To" userId="afe99e57b70de78c" providerId="LiveId" clId="{11F9E764-7024-B741-8C15-E26ECB229BA0}"/>
    <pc:docChg chg="undo redo custSel addSld delSld modSld sldOrd">
      <pc:chgData name="Alex To" userId="afe99e57b70de78c" providerId="LiveId" clId="{11F9E764-7024-B741-8C15-E26ECB229BA0}" dt="2024-03-06T11:33:42.240" v="2424" actId="20577"/>
      <pc:docMkLst>
        <pc:docMk/>
      </pc:docMkLst>
      <pc:sldChg chg="addSp modSp mod">
        <pc:chgData name="Alex To" userId="afe99e57b70de78c" providerId="LiveId" clId="{11F9E764-7024-B741-8C15-E26ECB229BA0}" dt="2024-03-06T10:19:10.025" v="2102" actId="1076"/>
        <pc:sldMkLst>
          <pc:docMk/>
          <pc:sldMk cId="1615469792" sldId="259"/>
        </pc:sldMkLst>
        <pc:spChg chg="mod">
          <ac:chgData name="Alex To" userId="afe99e57b70de78c" providerId="LiveId" clId="{11F9E764-7024-B741-8C15-E26ECB229BA0}" dt="2024-03-06T10:17:16.596" v="2099" actId="20577"/>
          <ac:spMkLst>
            <pc:docMk/>
            <pc:sldMk cId="1615469792" sldId="259"/>
            <ac:spMk id="2" creationId="{A3D3C0F6-3862-5A62-F7C7-AD6499CE11A0}"/>
          </ac:spMkLst>
        </pc:spChg>
        <pc:spChg chg="mod">
          <ac:chgData name="Alex To" userId="afe99e57b70de78c" providerId="LiveId" clId="{11F9E764-7024-B741-8C15-E26ECB229BA0}" dt="2024-03-06T10:17:17.985" v="2100" actId="20577"/>
          <ac:spMkLst>
            <pc:docMk/>
            <pc:sldMk cId="1615469792" sldId="259"/>
            <ac:spMk id="3" creationId="{1FCB92AB-60D1-7F4D-5419-C7041F6D5721}"/>
          </ac:spMkLst>
        </pc:spChg>
        <pc:spChg chg="mod">
          <ac:chgData name="Alex To" userId="afe99e57b70de78c" providerId="LiveId" clId="{11F9E764-7024-B741-8C15-E26ECB229BA0}" dt="2024-03-06T10:19:10.025" v="2102" actId="1076"/>
          <ac:spMkLst>
            <pc:docMk/>
            <pc:sldMk cId="1615469792" sldId="259"/>
            <ac:spMk id="5" creationId="{5E2298F5-FC6F-13F0-39CF-FAC84099F52C}"/>
          </ac:spMkLst>
        </pc:spChg>
        <pc:spChg chg="mod">
          <ac:chgData name="Alex To" userId="afe99e57b70de78c" providerId="LiveId" clId="{11F9E764-7024-B741-8C15-E26ECB229BA0}" dt="2024-03-05T12:07:11.689" v="20" actId="1076"/>
          <ac:spMkLst>
            <pc:docMk/>
            <pc:sldMk cId="1615469792" sldId="259"/>
            <ac:spMk id="9" creationId="{C1C1AFE5-0226-3391-4591-CCC7D9FFAB9E}"/>
          </ac:spMkLst>
        </pc:spChg>
        <pc:spChg chg="add mod">
          <ac:chgData name="Alex To" userId="afe99e57b70de78c" providerId="LiveId" clId="{11F9E764-7024-B741-8C15-E26ECB229BA0}" dt="2024-03-05T12:07:24.743" v="24" actId="1076"/>
          <ac:spMkLst>
            <pc:docMk/>
            <pc:sldMk cId="1615469792" sldId="259"/>
            <ac:spMk id="12" creationId="{00B09673-47BA-597B-1B9B-77081289497B}"/>
          </ac:spMkLst>
        </pc:spChg>
        <pc:spChg chg="add mod">
          <ac:chgData name="Alex To" userId="afe99e57b70de78c" providerId="LiveId" clId="{11F9E764-7024-B741-8C15-E26ECB229BA0}" dt="2024-03-05T12:07:40.448" v="35" actId="1076"/>
          <ac:spMkLst>
            <pc:docMk/>
            <pc:sldMk cId="1615469792" sldId="259"/>
            <ac:spMk id="13" creationId="{0B03FA15-43B3-1615-1491-723FBE4369D9}"/>
          </ac:spMkLst>
        </pc:spChg>
        <pc:picChg chg="mod">
          <ac:chgData name="Alex To" userId="afe99e57b70de78c" providerId="LiveId" clId="{11F9E764-7024-B741-8C15-E26ECB229BA0}" dt="2024-03-05T12:06:59.734" v="17" actId="14100"/>
          <ac:picMkLst>
            <pc:docMk/>
            <pc:sldMk cId="1615469792" sldId="259"/>
            <ac:picMk id="4" creationId="{CE11660C-71C9-65E2-9717-056A8467947F}"/>
          </ac:picMkLst>
        </pc:picChg>
        <pc:picChg chg="mod">
          <ac:chgData name="Alex To" userId="afe99e57b70de78c" providerId="LiveId" clId="{11F9E764-7024-B741-8C15-E26ECB229BA0}" dt="2024-03-05T12:30:58.474" v="105" actId="1076"/>
          <ac:picMkLst>
            <pc:docMk/>
            <pc:sldMk cId="1615469792" sldId="259"/>
            <ac:picMk id="8" creationId="{CC5BC97A-7AA4-84A9-C702-D06A1F1E0DB7}"/>
          </ac:picMkLst>
        </pc:picChg>
        <pc:picChg chg="add mod modCrop">
          <ac:chgData name="Alex To" userId="afe99e57b70de78c" providerId="LiveId" clId="{11F9E764-7024-B741-8C15-E26ECB229BA0}" dt="2024-03-05T12:08:39.782" v="84" actId="14100"/>
          <ac:picMkLst>
            <pc:docMk/>
            <pc:sldMk cId="1615469792" sldId="259"/>
            <ac:picMk id="11" creationId="{D0933A68-9208-5468-F7FD-9F559AEDCFC3}"/>
          </ac:picMkLst>
        </pc:picChg>
      </pc:sldChg>
      <pc:sldChg chg="addSp delSp modSp add mod ord">
        <pc:chgData name="Alex To" userId="afe99e57b70de78c" providerId="LiveId" clId="{11F9E764-7024-B741-8C15-E26ECB229BA0}" dt="2024-03-06T10:17:14.464" v="2098" actId="20577"/>
        <pc:sldMkLst>
          <pc:docMk/>
          <pc:sldMk cId="2709449790" sldId="261"/>
        </pc:sldMkLst>
        <pc:spChg chg="mod">
          <ac:chgData name="Alex To" userId="afe99e57b70de78c" providerId="LiveId" clId="{11F9E764-7024-B741-8C15-E26ECB229BA0}" dt="2024-03-06T10:17:12.926" v="2097" actId="20577"/>
          <ac:spMkLst>
            <pc:docMk/>
            <pc:sldMk cId="2709449790" sldId="261"/>
            <ac:spMk id="2" creationId="{A3D3C0F6-3862-5A62-F7C7-AD6499CE11A0}"/>
          </ac:spMkLst>
        </pc:spChg>
        <pc:spChg chg="mod">
          <ac:chgData name="Alex To" userId="afe99e57b70de78c" providerId="LiveId" clId="{11F9E764-7024-B741-8C15-E26ECB229BA0}" dt="2024-03-06T10:17:14.464" v="2098" actId="20577"/>
          <ac:spMkLst>
            <pc:docMk/>
            <pc:sldMk cId="2709449790" sldId="261"/>
            <ac:spMk id="3" creationId="{1FCB92AB-60D1-7F4D-5419-C7041F6D5721}"/>
          </ac:spMkLst>
        </pc:spChg>
        <pc:spChg chg="del">
          <ac:chgData name="Alex To" userId="afe99e57b70de78c" providerId="LiveId" clId="{11F9E764-7024-B741-8C15-E26ECB229BA0}" dt="2024-03-05T12:30:03.075" v="88" actId="478"/>
          <ac:spMkLst>
            <pc:docMk/>
            <pc:sldMk cId="2709449790" sldId="261"/>
            <ac:spMk id="5" creationId="{5E2298F5-FC6F-13F0-39CF-FAC84099F52C}"/>
          </ac:spMkLst>
        </pc:spChg>
        <pc:spChg chg="del">
          <ac:chgData name="Alex To" userId="afe99e57b70de78c" providerId="LiveId" clId="{11F9E764-7024-B741-8C15-E26ECB229BA0}" dt="2024-03-05T12:30:03.075" v="88" actId="478"/>
          <ac:spMkLst>
            <pc:docMk/>
            <pc:sldMk cId="2709449790" sldId="261"/>
            <ac:spMk id="7" creationId="{296B8522-7A62-6D8F-2F5D-D1B085361FAC}"/>
          </ac:spMkLst>
        </pc:spChg>
        <pc:spChg chg="del">
          <ac:chgData name="Alex To" userId="afe99e57b70de78c" providerId="LiveId" clId="{11F9E764-7024-B741-8C15-E26ECB229BA0}" dt="2024-03-05T12:30:03.075" v="88" actId="478"/>
          <ac:spMkLst>
            <pc:docMk/>
            <pc:sldMk cId="2709449790" sldId="261"/>
            <ac:spMk id="9" creationId="{C1C1AFE5-0226-3391-4591-CCC7D9FFAB9E}"/>
          </ac:spMkLst>
        </pc:spChg>
        <pc:spChg chg="mod">
          <ac:chgData name="Alex To" userId="afe99e57b70de78c" providerId="LiveId" clId="{11F9E764-7024-B741-8C15-E26ECB229BA0}" dt="2024-03-05T12:35:20.663" v="213" actId="1076"/>
          <ac:spMkLst>
            <pc:docMk/>
            <pc:sldMk cId="2709449790" sldId="261"/>
            <ac:spMk id="12" creationId="{00B09673-47BA-597B-1B9B-77081289497B}"/>
          </ac:spMkLst>
        </pc:spChg>
        <pc:spChg chg="del mod">
          <ac:chgData name="Alex To" userId="afe99e57b70de78c" providerId="LiveId" clId="{11F9E764-7024-B741-8C15-E26ECB229BA0}" dt="2024-03-05T12:32:37.736" v="139" actId="478"/>
          <ac:spMkLst>
            <pc:docMk/>
            <pc:sldMk cId="2709449790" sldId="261"/>
            <ac:spMk id="13" creationId="{0B03FA15-43B3-1615-1491-723FBE4369D9}"/>
          </ac:spMkLst>
        </pc:spChg>
        <pc:spChg chg="add mod">
          <ac:chgData name="Alex To" userId="afe99e57b70de78c" providerId="LiveId" clId="{11F9E764-7024-B741-8C15-E26ECB229BA0}" dt="2024-03-05T12:32:13.278" v="131" actId="1038"/>
          <ac:spMkLst>
            <pc:docMk/>
            <pc:sldMk cId="2709449790" sldId="261"/>
            <ac:spMk id="15" creationId="{54E8038D-38E7-6C65-669D-5B33E9969F22}"/>
          </ac:spMkLst>
        </pc:spChg>
        <pc:spChg chg="add mod">
          <ac:chgData name="Alex To" userId="afe99e57b70de78c" providerId="LiveId" clId="{11F9E764-7024-B741-8C15-E26ECB229BA0}" dt="2024-03-05T12:34:49.671" v="205" actId="1076"/>
          <ac:spMkLst>
            <pc:docMk/>
            <pc:sldMk cId="2709449790" sldId="261"/>
            <ac:spMk id="17" creationId="{9BAD417F-ED43-6FB1-2DD0-C635BC8EFEE7}"/>
          </ac:spMkLst>
        </pc:spChg>
        <pc:spChg chg="add mod">
          <ac:chgData name="Alex To" userId="afe99e57b70de78c" providerId="LiveId" clId="{11F9E764-7024-B741-8C15-E26ECB229BA0}" dt="2024-03-05T12:34:53.567" v="207" actId="1076"/>
          <ac:spMkLst>
            <pc:docMk/>
            <pc:sldMk cId="2709449790" sldId="261"/>
            <ac:spMk id="18" creationId="{4B75A034-2DB6-B73D-4AD2-4201F10E4785}"/>
          </ac:spMkLst>
        </pc:spChg>
        <pc:picChg chg="del">
          <ac:chgData name="Alex To" userId="afe99e57b70de78c" providerId="LiveId" clId="{11F9E764-7024-B741-8C15-E26ECB229BA0}" dt="2024-03-05T12:30:03.075" v="88" actId="478"/>
          <ac:picMkLst>
            <pc:docMk/>
            <pc:sldMk cId="2709449790" sldId="261"/>
            <ac:picMk id="4" creationId="{CE11660C-71C9-65E2-9717-056A8467947F}"/>
          </ac:picMkLst>
        </pc:picChg>
        <pc:picChg chg="del">
          <ac:chgData name="Alex To" userId="afe99e57b70de78c" providerId="LiveId" clId="{11F9E764-7024-B741-8C15-E26ECB229BA0}" dt="2024-03-05T12:30:03.075" v="88" actId="478"/>
          <ac:picMkLst>
            <pc:docMk/>
            <pc:sldMk cId="2709449790" sldId="261"/>
            <ac:picMk id="8" creationId="{CC5BC97A-7AA4-84A9-C702-D06A1F1E0DB7}"/>
          </ac:picMkLst>
        </pc:picChg>
        <pc:picChg chg="add mod">
          <ac:chgData name="Alex To" userId="afe99e57b70de78c" providerId="LiveId" clId="{11F9E764-7024-B741-8C15-E26ECB229BA0}" dt="2024-03-05T12:34:39.836" v="202" actId="1076"/>
          <ac:picMkLst>
            <pc:docMk/>
            <pc:sldMk cId="2709449790" sldId="261"/>
            <ac:picMk id="10" creationId="{4FC27C41-8823-8EFF-5040-9DC76CF1046F}"/>
          </ac:picMkLst>
        </pc:picChg>
        <pc:picChg chg="del mod">
          <ac:chgData name="Alex To" userId="afe99e57b70de78c" providerId="LiveId" clId="{11F9E764-7024-B741-8C15-E26ECB229BA0}" dt="2024-03-05T12:32:28.150" v="135" actId="478"/>
          <ac:picMkLst>
            <pc:docMk/>
            <pc:sldMk cId="2709449790" sldId="261"/>
            <ac:picMk id="11" creationId="{D0933A68-9208-5468-F7FD-9F559AEDCFC3}"/>
          </ac:picMkLst>
        </pc:picChg>
        <pc:picChg chg="add mod">
          <ac:chgData name="Alex To" userId="afe99e57b70de78c" providerId="LiveId" clId="{11F9E764-7024-B741-8C15-E26ECB229BA0}" dt="2024-03-05T12:34:53.567" v="207" actId="1076"/>
          <ac:picMkLst>
            <pc:docMk/>
            <pc:sldMk cId="2709449790" sldId="261"/>
            <ac:picMk id="14" creationId="{9BC961A5-D9A8-A357-E0E4-491AA49C9879}"/>
          </ac:picMkLst>
        </pc:picChg>
        <pc:picChg chg="add mod">
          <ac:chgData name="Alex To" userId="afe99e57b70de78c" providerId="LiveId" clId="{11F9E764-7024-B741-8C15-E26ECB229BA0}" dt="2024-03-06T07:53:01.398" v="1695" actId="14100"/>
          <ac:picMkLst>
            <pc:docMk/>
            <pc:sldMk cId="2709449790" sldId="261"/>
            <ac:picMk id="16" creationId="{C9EA8925-3DB6-E45A-CB69-BC5CE9DD8EA0}"/>
          </ac:picMkLst>
        </pc:picChg>
      </pc:sldChg>
      <pc:sldChg chg="addSp delSp modSp new mod">
        <pc:chgData name="Alex To" userId="afe99e57b70de78c" providerId="LiveId" clId="{11F9E764-7024-B741-8C15-E26ECB229BA0}" dt="2024-03-06T10:54:32.872" v="2272" actId="21"/>
        <pc:sldMkLst>
          <pc:docMk/>
          <pc:sldMk cId="3935208388" sldId="262"/>
        </pc:sldMkLst>
        <pc:spChg chg="add mod">
          <ac:chgData name="Alex To" userId="afe99e57b70de78c" providerId="LiveId" clId="{11F9E764-7024-B741-8C15-E26ECB229BA0}" dt="2024-03-06T01:51:47.014" v="430" actId="20577"/>
          <ac:spMkLst>
            <pc:docMk/>
            <pc:sldMk cId="3935208388" sldId="262"/>
            <ac:spMk id="2" creationId="{4426BB96-B9D4-9681-526B-90BCD7E82223}"/>
          </ac:spMkLst>
        </pc:spChg>
        <pc:spChg chg="add del mod">
          <ac:chgData name="Alex To" userId="afe99e57b70de78c" providerId="LiveId" clId="{11F9E764-7024-B741-8C15-E26ECB229BA0}" dt="2024-03-06T07:39:39.814" v="1396" actId="21"/>
          <ac:spMkLst>
            <pc:docMk/>
            <pc:sldMk cId="3935208388" sldId="262"/>
            <ac:spMk id="3" creationId="{95F066C5-5F29-0F6F-970E-720B8CC0A679}"/>
          </ac:spMkLst>
        </pc:spChg>
        <pc:spChg chg="add mod">
          <ac:chgData name="Alex To" userId="afe99e57b70de78c" providerId="LiveId" clId="{11F9E764-7024-B741-8C15-E26ECB229BA0}" dt="2024-03-06T07:49:43.261" v="1485" actId="1076"/>
          <ac:spMkLst>
            <pc:docMk/>
            <pc:sldMk cId="3935208388" sldId="262"/>
            <ac:spMk id="6" creationId="{B5C5012F-27FA-1F64-015E-D8513F1AB8B5}"/>
          </ac:spMkLst>
        </pc:spChg>
        <pc:spChg chg="add mod">
          <ac:chgData name="Alex To" userId="afe99e57b70de78c" providerId="LiveId" clId="{11F9E764-7024-B741-8C15-E26ECB229BA0}" dt="2024-03-06T07:49:12.120" v="1480" actId="1076"/>
          <ac:spMkLst>
            <pc:docMk/>
            <pc:sldMk cId="3935208388" sldId="262"/>
            <ac:spMk id="9" creationId="{4FED58CA-D864-9A57-7A23-4D27CE97D630}"/>
          </ac:spMkLst>
        </pc:spChg>
        <pc:spChg chg="add del mod">
          <ac:chgData name="Alex To" userId="afe99e57b70de78c" providerId="LiveId" clId="{11F9E764-7024-B741-8C15-E26ECB229BA0}" dt="2024-03-06T07:46:57.549" v="1462" actId="478"/>
          <ac:spMkLst>
            <pc:docMk/>
            <pc:sldMk cId="3935208388" sldId="262"/>
            <ac:spMk id="28" creationId="{1014E711-2E7A-E058-9A3A-A84A3B656D83}"/>
          </ac:spMkLst>
        </pc:spChg>
        <pc:spChg chg="add del">
          <ac:chgData name="Alex To" userId="afe99e57b70de78c" providerId="LiveId" clId="{11F9E764-7024-B741-8C15-E26ECB229BA0}" dt="2024-03-06T07:40:55.745" v="1416" actId="22"/>
          <ac:spMkLst>
            <pc:docMk/>
            <pc:sldMk cId="3935208388" sldId="262"/>
            <ac:spMk id="32" creationId="{68E3EC4B-7565-D05E-9034-B56DF070F924}"/>
          </ac:spMkLst>
        </pc:spChg>
        <pc:spChg chg="add mod">
          <ac:chgData name="Alex To" userId="afe99e57b70de78c" providerId="LiveId" clId="{11F9E764-7024-B741-8C15-E26ECB229BA0}" dt="2024-03-06T07:41:32.613" v="1424" actId="1076"/>
          <ac:spMkLst>
            <pc:docMk/>
            <pc:sldMk cId="3935208388" sldId="262"/>
            <ac:spMk id="34" creationId="{E7D685A5-057B-FFA3-FDAA-2442E6FA45CA}"/>
          </ac:spMkLst>
        </pc:spChg>
        <pc:spChg chg="add mod">
          <ac:chgData name="Alex To" userId="afe99e57b70de78c" providerId="LiveId" clId="{11F9E764-7024-B741-8C15-E26ECB229BA0}" dt="2024-03-06T10:47:37.323" v="2265" actId="113"/>
          <ac:spMkLst>
            <pc:docMk/>
            <pc:sldMk cId="3935208388" sldId="262"/>
            <ac:spMk id="36" creationId="{782F177E-94F3-F110-0868-DC53E559DAF7}"/>
          </ac:spMkLst>
        </pc:spChg>
        <pc:spChg chg="add mod">
          <ac:chgData name="Alex To" userId="afe99e57b70de78c" providerId="LiveId" clId="{11F9E764-7024-B741-8C15-E26ECB229BA0}" dt="2024-03-06T10:46:26.485" v="2158" actId="1076"/>
          <ac:spMkLst>
            <pc:docMk/>
            <pc:sldMk cId="3935208388" sldId="262"/>
            <ac:spMk id="47" creationId="{719507EE-CA83-1652-1061-7F7C1364E02B}"/>
          </ac:spMkLst>
        </pc:spChg>
        <pc:picChg chg="add del mod">
          <ac:chgData name="Alex To" userId="afe99e57b70de78c" providerId="LiveId" clId="{11F9E764-7024-B741-8C15-E26ECB229BA0}" dt="2024-03-06T03:03:54.060" v="536" actId="478"/>
          <ac:picMkLst>
            <pc:docMk/>
            <pc:sldMk cId="3935208388" sldId="262"/>
            <ac:picMk id="5" creationId="{F4302839-48B9-2842-7E8B-77C5375F73ED}"/>
          </ac:picMkLst>
        </pc:picChg>
        <pc:picChg chg="add del mod">
          <ac:chgData name="Alex To" userId="afe99e57b70de78c" providerId="LiveId" clId="{11F9E764-7024-B741-8C15-E26ECB229BA0}" dt="2024-03-06T04:03:18.469" v="595" actId="478"/>
          <ac:picMkLst>
            <pc:docMk/>
            <pc:sldMk cId="3935208388" sldId="262"/>
            <ac:picMk id="8" creationId="{B3581121-5397-3E34-418D-23415AAF6861}"/>
          </ac:picMkLst>
        </pc:picChg>
        <pc:picChg chg="add del mod">
          <ac:chgData name="Alex To" userId="afe99e57b70de78c" providerId="LiveId" clId="{11F9E764-7024-B741-8C15-E26ECB229BA0}" dt="2024-03-06T03:03:52.642" v="535" actId="478"/>
          <ac:picMkLst>
            <pc:docMk/>
            <pc:sldMk cId="3935208388" sldId="262"/>
            <ac:picMk id="11" creationId="{5512ECEE-D64D-044D-650F-721E94A72FCC}"/>
          </ac:picMkLst>
        </pc:picChg>
        <pc:picChg chg="add del mod">
          <ac:chgData name="Alex To" userId="afe99e57b70de78c" providerId="LiveId" clId="{11F9E764-7024-B741-8C15-E26ECB229BA0}" dt="2024-03-06T03:10:44.778" v="549" actId="478"/>
          <ac:picMkLst>
            <pc:docMk/>
            <pc:sldMk cId="3935208388" sldId="262"/>
            <ac:picMk id="13" creationId="{51404FC0-FD7A-ECC7-6829-624A8DE32866}"/>
          </ac:picMkLst>
        </pc:picChg>
        <pc:picChg chg="add del mod">
          <ac:chgData name="Alex To" userId="afe99e57b70de78c" providerId="LiveId" clId="{11F9E764-7024-B741-8C15-E26ECB229BA0}" dt="2024-03-06T03:16:44.143" v="558" actId="478"/>
          <ac:picMkLst>
            <pc:docMk/>
            <pc:sldMk cId="3935208388" sldId="262"/>
            <ac:picMk id="15" creationId="{E0B9251F-23D1-4218-EEE9-4E1D0C962CFB}"/>
          </ac:picMkLst>
        </pc:picChg>
        <pc:picChg chg="add del mod">
          <ac:chgData name="Alex To" userId="afe99e57b70de78c" providerId="LiveId" clId="{11F9E764-7024-B741-8C15-E26ECB229BA0}" dt="2024-03-06T03:20:30.879" v="586" actId="478"/>
          <ac:picMkLst>
            <pc:docMk/>
            <pc:sldMk cId="3935208388" sldId="262"/>
            <ac:picMk id="17" creationId="{57B8499C-B263-1D4F-71DB-13101857DA49}"/>
          </ac:picMkLst>
        </pc:picChg>
        <pc:picChg chg="add del mod">
          <ac:chgData name="Alex To" userId="afe99e57b70de78c" providerId="LiveId" clId="{11F9E764-7024-B741-8C15-E26ECB229BA0}" dt="2024-03-06T03:20:14.121" v="575" actId="478"/>
          <ac:picMkLst>
            <pc:docMk/>
            <pc:sldMk cId="3935208388" sldId="262"/>
            <ac:picMk id="19" creationId="{52722B06-E029-82E7-465B-5AADB29F38F2}"/>
          </ac:picMkLst>
        </pc:picChg>
        <pc:picChg chg="add mod modCrop">
          <ac:chgData name="Alex To" userId="afe99e57b70de78c" providerId="LiveId" clId="{11F9E764-7024-B741-8C15-E26ECB229BA0}" dt="2024-03-06T07:49:24.046" v="1481" actId="14100"/>
          <ac:picMkLst>
            <pc:docMk/>
            <pc:sldMk cId="3935208388" sldId="262"/>
            <ac:picMk id="21" creationId="{AE4079D1-E14E-8543-C21B-EC076D08B7F7}"/>
          </ac:picMkLst>
        </pc:picChg>
        <pc:picChg chg="add del mod">
          <ac:chgData name="Alex To" userId="afe99e57b70de78c" providerId="LiveId" clId="{11F9E764-7024-B741-8C15-E26ECB229BA0}" dt="2024-03-06T04:03:39.691" v="600" actId="478"/>
          <ac:picMkLst>
            <pc:docMk/>
            <pc:sldMk cId="3935208388" sldId="262"/>
            <ac:picMk id="23" creationId="{0DF78BDE-328F-9309-EF70-060F7EFB4132}"/>
          </ac:picMkLst>
        </pc:picChg>
        <pc:picChg chg="add del mod">
          <ac:chgData name="Alex To" userId="afe99e57b70de78c" providerId="LiveId" clId="{11F9E764-7024-B741-8C15-E26ECB229BA0}" dt="2024-03-06T04:14:05.058" v="613" actId="478"/>
          <ac:picMkLst>
            <pc:docMk/>
            <pc:sldMk cId="3935208388" sldId="262"/>
            <ac:picMk id="25" creationId="{3D531868-445F-45D3-457F-C085269C09C0}"/>
          </ac:picMkLst>
        </pc:picChg>
        <pc:picChg chg="add mod modCrop">
          <ac:chgData name="Alex To" userId="afe99e57b70de78c" providerId="LiveId" clId="{11F9E764-7024-B741-8C15-E26ECB229BA0}" dt="2024-03-06T10:45:25.050" v="2141" actId="14100"/>
          <ac:picMkLst>
            <pc:docMk/>
            <pc:sldMk cId="3935208388" sldId="262"/>
            <ac:picMk id="27" creationId="{5C025D30-F00D-9FE7-5BEF-796872923923}"/>
          </ac:picMkLst>
        </pc:picChg>
        <pc:picChg chg="add del mod">
          <ac:chgData name="Alex To" userId="afe99e57b70de78c" providerId="LiveId" clId="{11F9E764-7024-B741-8C15-E26ECB229BA0}" dt="2024-03-06T07:46:55.931" v="1461" actId="21"/>
          <ac:picMkLst>
            <pc:docMk/>
            <pc:sldMk cId="3935208388" sldId="262"/>
            <ac:picMk id="30" creationId="{37C3A0CD-352C-67FD-FA10-B8511F958CBB}"/>
          </ac:picMkLst>
        </pc:picChg>
        <pc:picChg chg="add del mod">
          <ac:chgData name="Alex To" userId="afe99e57b70de78c" providerId="LiveId" clId="{11F9E764-7024-B741-8C15-E26ECB229BA0}" dt="2024-03-06T07:44:01.981" v="1434" actId="478"/>
          <ac:picMkLst>
            <pc:docMk/>
            <pc:sldMk cId="3935208388" sldId="262"/>
            <ac:picMk id="33" creationId="{23DB022C-488E-719C-7850-284539D6409B}"/>
          </ac:picMkLst>
        </pc:picChg>
        <pc:picChg chg="add mod modCrop">
          <ac:chgData name="Alex To" userId="afe99e57b70de78c" providerId="LiveId" clId="{11F9E764-7024-B741-8C15-E26ECB229BA0}" dt="2024-03-06T07:49:47.539" v="1487" actId="1076"/>
          <ac:picMkLst>
            <pc:docMk/>
            <pc:sldMk cId="3935208388" sldId="262"/>
            <ac:picMk id="35" creationId="{9A50A9AE-3ABC-9268-E46D-C955FF76F2D0}"/>
          </ac:picMkLst>
        </pc:picChg>
        <pc:picChg chg="add del mod">
          <ac:chgData name="Alex To" userId="afe99e57b70de78c" providerId="LiveId" clId="{11F9E764-7024-B741-8C15-E26ECB229BA0}" dt="2024-03-06T10:41:38.855" v="2108" actId="478"/>
          <ac:picMkLst>
            <pc:docMk/>
            <pc:sldMk cId="3935208388" sldId="262"/>
            <ac:picMk id="38" creationId="{AFEA8811-4AB1-9F5C-1EE1-F57DA2164497}"/>
          </ac:picMkLst>
        </pc:picChg>
        <pc:picChg chg="add del mod">
          <ac:chgData name="Alex To" userId="afe99e57b70de78c" providerId="LiveId" clId="{11F9E764-7024-B741-8C15-E26ECB229BA0}" dt="2024-03-06T10:42:06.677" v="2114" actId="478"/>
          <ac:picMkLst>
            <pc:docMk/>
            <pc:sldMk cId="3935208388" sldId="262"/>
            <ac:picMk id="40" creationId="{3ACB00DE-2D6B-EEAD-3C64-8EFBB0704D78}"/>
          </ac:picMkLst>
        </pc:picChg>
        <pc:picChg chg="add del mod">
          <ac:chgData name="Alex To" userId="afe99e57b70de78c" providerId="LiveId" clId="{11F9E764-7024-B741-8C15-E26ECB229BA0}" dt="2024-03-06T10:44:09.049" v="2131" actId="478"/>
          <ac:picMkLst>
            <pc:docMk/>
            <pc:sldMk cId="3935208388" sldId="262"/>
            <ac:picMk id="42" creationId="{31417942-AE56-F5A6-1F96-BEB09DE0EE88}"/>
          </ac:picMkLst>
        </pc:picChg>
        <pc:picChg chg="add del mod">
          <ac:chgData name="Alex To" userId="afe99e57b70de78c" providerId="LiveId" clId="{11F9E764-7024-B741-8C15-E26ECB229BA0}" dt="2024-03-06T10:44:41.643" v="2134" actId="478"/>
          <ac:picMkLst>
            <pc:docMk/>
            <pc:sldMk cId="3935208388" sldId="262"/>
            <ac:picMk id="44" creationId="{10F91729-4B6D-895E-942A-7FC67E3F6684}"/>
          </ac:picMkLst>
        </pc:picChg>
        <pc:picChg chg="add del mod modCrop">
          <ac:chgData name="Alex To" userId="afe99e57b70de78c" providerId="LiveId" clId="{11F9E764-7024-B741-8C15-E26ECB229BA0}" dt="2024-03-06T10:46:02.999" v="2149" actId="478"/>
          <ac:picMkLst>
            <pc:docMk/>
            <pc:sldMk cId="3935208388" sldId="262"/>
            <ac:picMk id="45" creationId="{1E573329-3F91-94A0-BD06-BB00A8AB549B}"/>
          </ac:picMkLst>
        </pc:picChg>
        <pc:picChg chg="add mod modCrop">
          <ac:chgData name="Alex To" userId="afe99e57b70de78c" providerId="LiveId" clId="{11F9E764-7024-B741-8C15-E26ECB229BA0}" dt="2024-03-06T10:46:15.819" v="2154" actId="14100"/>
          <ac:picMkLst>
            <pc:docMk/>
            <pc:sldMk cId="3935208388" sldId="262"/>
            <ac:picMk id="46" creationId="{8F665493-2158-B54B-A0F8-FC31EAF7018A}"/>
          </ac:picMkLst>
        </pc:picChg>
        <pc:picChg chg="add del">
          <ac:chgData name="Alex To" userId="afe99e57b70de78c" providerId="LiveId" clId="{11F9E764-7024-B741-8C15-E26ECB229BA0}" dt="2024-03-06T10:54:32.872" v="2272" actId="21"/>
          <ac:picMkLst>
            <pc:docMk/>
            <pc:sldMk cId="3935208388" sldId="262"/>
            <ac:picMk id="48" creationId="{CC317084-EA41-D901-824D-745369AEAF42}"/>
          </ac:picMkLst>
        </pc:picChg>
      </pc:sldChg>
      <pc:sldChg chg="addSp delSp modSp new del mod modClrScheme chgLayout">
        <pc:chgData name="Alex To" userId="afe99e57b70de78c" providerId="LiveId" clId="{11F9E764-7024-B741-8C15-E26ECB229BA0}" dt="2024-03-06T07:48:49.089" v="1472" actId="2696"/>
        <pc:sldMkLst>
          <pc:docMk/>
          <pc:sldMk cId="4188680171" sldId="263"/>
        </pc:sldMkLst>
        <pc:spChg chg="add del mod">
          <ac:chgData name="Alex To" userId="afe99e57b70de78c" providerId="LiveId" clId="{11F9E764-7024-B741-8C15-E26ECB229BA0}" dt="2024-03-06T07:18:14.880" v="635" actId="700"/>
          <ac:spMkLst>
            <pc:docMk/>
            <pc:sldMk cId="4188680171" sldId="263"/>
            <ac:spMk id="2" creationId="{3C803ECE-F771-85A6-93F3-D454E29A0EB4}"/>
          </ac:spMkLst>
        </pc:spChg>
        <pc:spChg chg="add mod">
          <ac:chgData name="Alex To" userId="afe99e57b70de78c" providerId="LiveId" clId="{11F9E764-7024-B741-8C15-E26ECB229BA0}" dt="2024-03-06T07:18:22.019" v="644" actId="20577"/>
          <ac:spMkLst>
            <pc:docMk/>
            <pc:sldMk cId="4188680171" sldId="263"/>
            <ac:spMk id="3" creationId="{31DC180C-05A7-F0B0-D492-1AFCCE74F00C}"/>
          </ac:spMkLst>
        </pc:spChg>
        <pc:spChg chg="add del">
          <ac:chgData name="Alex To" userId="afe99e57b70de78c" providerId="LiveId" clId="{11F9E764-7024-B741-8C15-E26ECB229BA0}" dt="2024-03-06T07:18:26.085" v="646" actId="22"/>
          <ac:spMkLst>
            <pc:docMk/>
            <pc:sldMk cId="4188680171" sldId="263"/>
            <ac:spMk id="5" creationId="{4A7CF518-3830-8BD3-1CB4-EBC2AB8B9371}"/>
          </ac:spMkLst>
        </pc:spChg>
        <pc:spChg chg="add del mod">
          <ac:chgData name="Alex To" userId="afe99e57b70de78c" providerId="LiveId" clId="{11F9E764-7024-B741-8C15-E26ECB229BA0}" dt="2024-03-06T07:18:29.438" v="650" actId="478"/>
          <ac:spMkLst>
            <pc:docMk/>
            <pc:sldMk cId="4188680171" sldId="263"/>
            <ac:spMk id="6" creationId="{9F586E0C-29F0-097C-62DB-05766A533961}"/>
          </ac:spMkLst>
        </pc:spChg>
        <pc:graphicFrameChg chg="add mod modGraphic">
          <ac:chgData name="Alex To" userId="afe99e57b70de78c" providerId="LiveId" clId="{11F9E764-7024-B741-8C15-E26ECB229BA0}" dt="2024-03-06T07:20:35.958" v="664" actId="1076"/>
          <ac:graphicFrameMkLst>
            <pc:docMk/>
            <pc:sldMk cId="4188680171" sldId="263"/>
            <ac:graphicFrameMk id="8" creationId="{5523D2B4-E775-4E1F-905B-4B1E6CE400CC}"/>
          </ac:graphicFrameMkLst>
        </pc:graphicFrameChg>
        <pc:picChg chg="add del mod">
          <ac:chgData name="Alex To" userId="afe99e57b70de78c" providerId="LiveId" clId="{11F9E764-7024-B741-8C15-E26ECB229BA0}" dt="2024-03-06T07:19:37.545" v="653" actId="478"/>
          <ac:picMkLst>
            <pc:docMk/>
            <pc:sldMk cId="4188680171" sldId="263"/>
            <ac:picMk id="7" creationId="{AD52FB39-924B-CFD9-137E-A7F152A1018B}"/>
          </ac:picMkLst>
        </pc:picChg>
      </pc:sldChg>
      <pc:sldChg chg="addSp delSp modSp new del mod">
        <pc:chgData name="Alex To" userId="afe99e57b70de78c" providerId="LiveId" clId="{11F9E764-7024-B741-8C15-E26ECB229BA0}" dt="2024-03-06T07:48:59.616" v="1476" actId="2696"/>
        <pc:sldMkLst>
          <pc:docMk/>
          <pc:sldMk cId="2870762845" sldId="264"/>
        </pc:sldMkLst>
        <pc:spChg chg="add del mod">
          <ac:chgData name="Alex To" userId="afe99e57b70de78c" providerId="LiveId" clId="{11F9E764-7024-B741-8C15-E26ECB229BA0}" dt="2024-03-06T07:48:58.293" v="1475" actId="21"/>
          <ac:spMkLst>
            <pc:docMk/>
            <pc:sldMk cId="2870762845" sldId="264"/>
            <ac:spMk id="2" creationId="{56D3760D-2981-EE6D-E49E-77239DABBD1E}"/>
          </ac:spMkLst>
        </pc:spChg>
        <pc:spChg chg="add mod">
          <ac:chgData name="Alex To" userId="afe99e57b70de78c" providerId="LiveId" clId="{11F9E764-7024-B741-8C15-E26ECB229BA0}" dt="2024-03-06T07:48:54.413" v="1474" actId="20577"/>
          <ac:spMkLst>
            <pc:docMk/>
            <pc:sldMk cId="2870762845" sldId="264"/>
            <ac:spMk id="3" creationId="{BAD286EA-8C3D-1EDA-6B61-5E8F4FBF32D9}"/>
          </ac:spMkLst>
        </pc:spChg>
      </pc:sldChg>
      <pc:sldChg chg="addSp delSp modSp new mod">
        <pc:chgData name="Alex To" userId="afe99e57b70de78c" providerId="LiveId" clId="{11F9E764-7024-B741-8C15-E26ECB229BA0}" dt="2024-03-06T11:33:42.240" v="2424" actId="20577"/>
        <pc:sldMkLst>
          <pc:docMk/>
          <pc:sldMk cId="1999014981" sldId="265"/>
        </pc:sldMkLst>
        <pc:spChg chg="add mod">
          <ac:chgData name="Alex To" userId="afe99e57b70de78c" providerId="LiveId" clId="{11F9E764-7024-B741-8C15-E26ECB229BA0}" dt="2024-03-06T07:46:53.753" v="1460" actId="20577"/>
          <ac:spMkLst>
            <pc:docMk/>
            <pc:sldMk cId="1999014981" sldId="265"/>
            <ac:spMk id="2" creationId="{5A4E5CE9-5089-9271-119B-C4B1D2D60732}"/>
          </ac:spMkLst>
        </pc:spChg>
        <pc:spChg chg="add mod">
          <ac:chgData name="Alex To" userId="afe99e57b70de78c" providerId="LiveId" clId="{11F9E764-7024-B741-8C15-E26ECB229BA0}" dt="2024-03-06T08:12:29.467" v="1895" actId="20577"/>
          <ac:spMkLst>
            <pc:docMk/>
            <pc:sldMk cId="1999014981" sldId="265"/>
            <ac:spMk id="4" creationId="{98CB7DEF-7021-80D5-A0D5-2E2695DFD214}"/>
          </ac:spMkLst>
        </pc:spChg>
        <pc:spChg chg="add mod">
          <ac:chgData name="Alex To" userId="afe99e57b70de78c" providerId="LiveId" clId="{11F9E764-7024-B741-8C15-E26ECB229BA0}" dt="2024-03-06T11:33:42.240" v="2424" actId="20577"/>
          <ac:spMkLst>
            <pc:docMk/>
            <pc:sldMk cId="1999014981" sldId="265"/>
            <ac:spMk id="5" creationId="{60656A93-1BCA-2ED8-461C-33D4025A9225}"/>
          </ac:spMkLst>
        </pc:spChg>
        <pc:picChg chg="add del mod">
          <ac:chgData name="Alex To" userId="afe99e57b70de78c" providerId="LiveId" clId="{11F9E764-7024-B741-8C15-E26ECB229BA0}" dt="2024-03-06T07:58:51.976" v="1850" actId="478"/>
          <ac:picMkLst>
            <pc:docMk/>
            <pc:sldMk cId="1999014981" sldId="265"/>
            <ac:picMk id="3" creationId="{0265BD9B-FD3A-36D1-CFEE-C079666654CE}"/>
          </ac:picMkLst>
        </pc:picChg>
        <pc:picChg chg="add mod">
          <ac:chgData name="Alex To" userId="afe99e57b70de78c" providerId="LiveId" clId="{11F9E764-7024-B741-8C15-E26ECB229BA0}" dt="2024-03-06T07:59:01.276" v="1857" actId="1076"/>
          <ac:picMkLst>
            <pc:docMk/>
            <pc:sldMk cId="1999014981" sldId="265"/>
            <ac:picMk id="7" creationId="{DAB0645D-436C-D3E0-95BC-5E3D3CAB1A1F}"/>
          </ac:picMkLst>
        </pc:picChg>
        <pc:picChg chg="add del mod">
          <ac:chgData name="Alex To" userId="afe99e57b70de78c" providerId="LiveId" clId="{11F9E764-7024-B741-8C15-E26ECB229BA0}" dt="2024-03-06T08:09:35.512" v="1869" actId="478"/>
          <ac:picMkLst>
            <pc:docMk/>
            <pc:sldMk cId="1999014981" sldId="265"/>
            <ac:picMk id="9" creationId="{46EA80FA-E368-266B-5829-F9FDEA9C7EDD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2E23D6-7670-B34D-9A13-8F74D46B230F}" type="datetimeFigureOut">
              <a:rPr lang="en-US" smtClean="0"/>
              <a:t>3/5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3B1C61-264D-0341-BEA6-35D83D1556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2152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3B1C61-264D-0341-BEA6-35D83D1556E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9993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3B1C61-264D-0341-BEA6-35D83D1556E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77566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13B1C61-264D-0341-BEA6-35D83D1556EE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31454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571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986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091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1988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7110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065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450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60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1203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593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2098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B6ADA-D2BE-4D40-BE5B-D2FA729BAA68}" type="datetimeFigureOut">
              <a:rPr lang="en-US" smtClean="0"/>
              <a:t>3/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454B7-47C2-BE42-9C2E-51DC22EB10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3492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rios@hku.hk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EBFA019-DDA6-2EB6-D40D-B8011CC984C1}"/>
              </a:ext>
            </a:extLst>
          </p:cNvPr>
          <p:cNvSpPr txBox="1"/>
          <p:nvPr/>
        </p:nvSpPr>
        <p:spPr>
          <a:xfrm>
            <a:off x="199293" y="105508"/>
            <a:ext cx="6447692" cy="88639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HK" sz="18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information for</a:t>
            </a:r>
          </a:p>
          <a:p>
            <a:pPr algn="just">
              <a:lnSpc>
                <a:spcPct val="200000"/>
              </a:lnSpc>
            </a:pPr>
            <a:endParaRPr lang="en-HK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8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ARS-CoV-2 infection activates inflammatory macrophages in vascular immune organoids</a:t>
            </a:r>
          </a:p>
          <a:p>
            <a:pPr>
              <a:lnSpc>
                <a:spcPct val="200000"/>
              </a:lnSpc>
            </a:pP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u Wang Chau1*, Alex To1*, Rex K.H. Au-Yeung2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Kaiming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ang3, Yang Xiang1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egong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Ruan1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anlan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Zhang4, Hera Wong1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hihui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Zhang1, Man Ting Au4, Seok Chung5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uijeong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Song6, Dong-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ee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Choi5, 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Pentao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Liu1,7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huofeng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Yuan3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unyi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Wen4#,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yohichi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Sugimura1,7#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 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1 School of Biomedical Sciences, Li Ka Shing Faculty of Medicine, The University of Hong Kong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2 Department of Pathology, Li Ka Shing Faculty of Medicine, The University of Hong Kong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3 Department of Microbiology, Li Ka Shing Faculty of Medicine, The University of Hong Kong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4 Department of Biomedical Engineering, The Hong Kong Polytechnic University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5 Korea University, South Korea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6 </a:t>
            </a:r>
            <a:r>
              <a:rPr lang="en-HK" sz="12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ext&amp;Bio</a:t>
            </a: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Inc, South Korea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7 Centre for Translational Stem Cell Biology, Hong Kong</a:t>
            </a:r>
            <a:br>
              <a:rPr lang="en-HK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* equal contribution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HK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# corresponding </a:t>
            </a:r>
            <a:r>
              <a:rPr lang="en-HK" sz="1200" u="sng" dirty="0">
                <a:solidFill>
                  <a:srgbClr val="0563C1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hlinkClick r:id="rId3"/>
              </a:rPr>
              <a:t>rios@hku.hk</a:t>
            </a:r>
            <a:endParaRPr lang="en-HK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09894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 descr="A grey rectangular object with dots on it&#10;&#10;Description automatically generated">
            <a:extLst>
              <a:ext uri="{FF2B5EF4-FFF2-40B4-BE49-F238E27FC236}">
                <a16:creationId xmlns:a16="http://schemas.microsoft.com/office/drawing/2014/main" id="{C9EA8925-3DB6-E45A-CB69-BC5CE9DD8EA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00" y="3297237"/>
            <a:ext cx="2425300" cy="319625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3D3C0F6-3862-5A62-F7C7-AD6499CE11A0}"/>
              </a:ext>
            </a:extLst>
          </p:cNvPr>
          <p:cNvSpPr txBox="1"/>
          <p:nvPr/>
        </p:nvSpPr>
        <p:spPr>
          <a:xfrm>
            <a:off x="70338" y="124126"/>
            <a:ext cx="2568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1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2582D61-C16A-4DCE-FD55-A9B99B6FF78B}"/>
              </a:ext>
            </a:extLst>
          </p:cNvPr>
          <p:cNvSpPr txBox="1"/>
          <p:nvPr/>
        </p:nvSpPr>
        <p:spPr>
          <a:xfrm>
            <a:off x="126645" y="554832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FCB92AB-60D1-7F4D-5419-C7041F6D5721}"/>
              </a:ext>
            </a:extLst>
          </p:cNvPr>
          <p:cNvSpPr txBox="1"/>
          <p:nvPr/>
        </p:nvSpPr>
        <p:spPr>
          <a:xfrm>
            <a:off x="368300" y="6436759"/>
            <a:ext cx="6377353" cy="22307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/>
              <a:t>Supplementary figure 1. Apoptosis of the infected VO. </a:t>
            </a:r>
            <a:r>
              <a:rPr lang="en-US" dirty="0"/>
              <a:t>Immunohistochemistry staining of cleaved caspase-3 on </a:t>
            </a:r>
            <a:r>
              <a:rPr lang="en-US" b="1" dirty="0"/>
              <a:t>(A) </a:t>
            </a:r>
            <a:r>
              <a:rPr lang="en-US" dirty="0"/>
              <a:t>mock and </a:t>
            </a:r>
            <a:r>
              <a:rPr lang="en-US" b="1" dirty="0"/>
              <a:t>(B)</a:t>
            </a:r>
            <a:r>
              <a:rPr lang="en-US" dirty="0"/>
              <a:t> infected VOs. Scale bar = 50 </a:t>
            </a:r>
            <a:r>
              <a:rPr lang="el-GR" dirty="0"/>
              <a:t>μ</a:t>
            </a:r>
            <a:r>
              <a:rPr lang="en-US" dirty="0"/>
              <a:t>m. </a:t>
            </a:r>
            <a:r>
              <a:rPr lang="en-US" b="1" dirty="0"/>
              <a:t>(C)</a:t>
            </a:r>
            <a:r>
              <a:rPr lang="en-US" dirty="0"/>
              <a:t> Quantitative analysis of (A) and (B).</a:t>
            </a:r>
            <a:r>
              <a:rPr lang="en-US" b="1" dirty="0"/>
              <a:t> </a:t>
            </a:r>
            <a:r>
              <a:rPr lang="en-US" dirty="0"/>
              <a:t>** p &lt;0.01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0B09673-47BA-597B-1B9B-77081289497B}"/>
              </a:ext>
            </a:extLst>
          </p:cNvPr>
          <p:cNvSpPr txBox="1"/>
          <p:nvPr/>
        </p:nvSpPr>
        <p:spPr>
          <a:xfrm>
            <a:off x="157770" y="3332163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pic>
        <p:nvPicPr>
          <p:cNvPr id="10" name="Picture 9" descr="A microscope view of a cell&#10;&#10;Description automatically generated">
            <a:extLst>
              <a:ext uri="{FF2B5EF4-FFF2-40B4-BE49-F238E27FC236}">
                <a16:creationId xmlns:a16="http://schemas.microsoft.com/office/drawing/2014/main" id="{4FC27C41-8823-8EFF-5040-9DC76CF1046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00" y="1000125"/>
            <a:ext cx="2927771" cy="2196000"/>
          </a:xfrm>
          <a:prstGeom prst="rect">
            <a:avLst/>
          </a:prstGeom>
        </p:spPr>
      </p:pic>
      <p:pic>
        <p:nvPicPr>
          <p:cNvPr id="14" name="Picture 13" descr="A close-up of a cell&#10;&#10;Description automatically generated">
            <a:extLst>
              <a:ext uri="{FF2B5EF4-FFF2-40B4-BE49-F238E27FC236}">
                <a16:creationId xmlns:a16="http://schemas.microsoft.com/office/drawing/2014/main" id="{9BC961A5-D9A8-A357-E0E4-491AA49C987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4804" y="985282"/>
            <a:ext cx="2927771" cy="2196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54E8038D-38E7-6C65-669D-5B33E9969F22}"/>
              </a:ext>
            </a:extLst>
          </p:cNvPr>
          <p:cNvSpPr txBox="1"/>
          <p:nvPr/>
        </p:nvSpPr>
        <p:spPr>
          <a:xfrm>
            <a:off x="3493297" y="567315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BAD417F-ED43-6FB1-2DD0-C635BC8EFEE7}"/>
              </a:ext>
            </a:extLst>
          </p:cNvPr>
          <p:cNvSpPr txBox="1"/>
          <p:nvPr/>
        </p:nvSpPr>
        <p:spPr>
          <a:xfrm>
            <a:off x="1466850" y="641350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ck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B75A034-2DB6-B73D-4AD2-4201F10E4785}"/>
              </a:ext>
            </a:extLst>
          </p:cNvPr>
          <p:cNvSpPr txBox="1"/>
          <p:nvPr/>
        </p:nvSpPr>
        <p:spPr>
          <a:xfrm>
            <a:off x="4678217" y="631825"/>
            <a:ext cx="9652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nfected</a:t>
            </a:r>
          </a:p>
        </p:txBody>
      </p:sp>
    </p:spTree>
    <p:extLst>
      <p:ext uri="{BB962C8B-B14F-4D97-AF65-F5344CB8AC3E}">
        <p14:creationId xmlns:p14="http://schemas.microsoft.com/office/powerpoint/2010/main" val="27094497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3D3C0F6-3862-5A62-F7C7-AD6499CE11A0}"/>
              </a:ext>
            </a:extLst>
          </p:cNvPr>
          <p:cNvSpPr txBox="1"/>
          <p:nvPr/>
        </p:nvSpPr>
        <p:spPr>
          <a:xfrm>
            <a:off x="70338" y="124126"/>
            <a:ext cx="2568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2. </a:t>
            </a:r>
          </a:p>
        </p:txBody>
      </p:sp>
      <p:pic>
        <p:nvPicPr>
          <p:cNvPr id="4" name="Picture 3" descr="A close up of a rock&#10;&#10;Description automatically generated">
            <a:extLst>
              <a:ext uri="{FF2B5EF4-FFF2-40B4-BE49-F238E27FC236}">
                <a16:creationId xmlns:a16="http://schemas.microsoft.com/office/drawing/2014/main" id="{CE11660C-71C9-65E2-9717-056A8467947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325" y="626098"/>
            <a:ext cx="2576172" cy="257617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96B8522-7A62-6D8F-2F5D-D1B085361FAC}"/>
              </a:ext>
            </a:extLst>
          </p:cNvPr>
          <p:cNvSpPr txBox="1"/>
          <p:nvPr/>
        </p:nvSpPr>
        <p:spPr>
          <a:xfrm>
            <a:off x="341902" y="573061"/>
            <a:ext cx="11013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800" kern="100" dirty="0">
                <a:solidFill>
                  <a:srgbClr val="70AD47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vWF </a:t>
            </a:r>
            <a:r>
              <a:rPr lang="en-HK" sz="1800" kern="100" dirty="0">
                <a:solidFill>
                  <a:srgbClr val="4472C4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DAPI</a:t>
            </a:r>
            <a:endParaRPr lang="en-HK" sz="1800" kern="100" dirty="0">
              <a:effectLst/>
              <a:latin typeface="Calibri" panose="020F0502020204030204" pitchFamily="34" charset="0"/>
              <a:ea typeface="PMingLiU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2582D61-C16A-4DCE-FD55-A9B99B6FF78B}"/>
              </a:ext>
            </a:extLst>
          </p:cNvPr>
          <p:cNvSpPr txBox="1"/>
          <p:nvPr/>
        </p:nvSpPr>
        <p:spPr>
          <a:xfrm>
            <a:off x="126645" y="554832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pic>
        <p:nvPicPr>
          <p:cNvPr id="8" name="Picture 7" descr="A red blob of a fish&#10;&#10;Description automatically generated">
            <a:extLst>
              <a:ext uri="{FF2B5EF4-FFF2-40B4-BE49-F238E27FC236}">
                <a16:creationId xmlns:a16="http://schemas.microsoft.com/office/drawing/2014/main" id="{CC5BC97A-7AA4-84A9-C702-D06A1F1E0DB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84" t="28342" b="1"/>
          <a:stretch/>
        </p:blipFill>
        <p:spPr bwMode="auto">
          <a:xfrm>
            <a:off x="3261621" y="631825"/>
            <a:ext cx="3370954" cy="259386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1C1AFE5-0226-3391-4591-CCC7D9FFAB9E}"/>
              </a:ext>
            </a:extLst>
          </p:cNvPr>
          <p:cNvSpPr txBox="1"/>
          <p:nvPr/>
        </p:nvSpPr>
        <p:spPr>
          <a:xfrm>
            <a:off x="3047882" y="551775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FCB92AB-60D1-7F4D-5419-C7041F6D5721}"/>
              </a:ext>
            </a:extLst>
          </p:cNvPr>
          <p:cNvSpPr txBox="1"/>
          <p:nvPr/>
        </p:nvSpPr>
        <p:spPr>
          <a:xfrm>
            <a:off x="271224" y="5992078"/>
            <a:ext cx="6377353" cy="27847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/>
              <a:t>Supplementary figure 2. Characterization of SARS-CoV-2 infected vascular organoids and vascular immune organoids. (A) </a:t>
            </a:r>
            <a:r>
              <a:rPr lang="en-US" dirty="0"/>
              <a:t>vWF immunofluorescent staining of VO. Scale bar = 100 </a:t>
            </a:r>
            <a:r>
              <a:rPr lang="el-GR" dirty="0"/>
              <a:t>μ</a:t>
            </a:r>
            <a:r>
              <a:rPr lang="en-US" dirty="0"/>
              <a:t>m. </a:t>
            </a:r>
            <a:r>
              <a:rPr lang="en-US" b="1" dirty="0"/>
              <a:t>(B)</a:t>
            </a:r>
            <a:r>
              <a:rPr lang="en-US" dirty="0"/>
              <a:t> N-protein (NP) immunofluorescent staining of VIOs. </a:t>
            </a:r>
            <a:r>
              <a:rPr lang="en-US" b="1" dirty="0"/>
              <a:t>(C)</a:t>
            </a:r>
            <a:r>
              <a:rPr lang="en-US" dirty="0"/>
              <a:t> IL6 immunohistochemistry staining of VIOs.</a:t>
            </a:r>
            <a:r>
              <a:rPr lang="en-US" b="1" dirty="0"/>
              <a:t> </a:t>
            </a:r>
            <a:r>
              <a:rPr lang="en-US" dirty="0"/>
              <a:t>Scale bar = 200 </a:t>
            </a:r>
            <a:r>
              <a:rPr lang="el-GR" dirty="0"/>
              <a:t>μ</a:t>
            </a:r>
            <a:r>
              <a:rPr lang="en-US" dirty="0"/>
              <a:t>m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E2298F5-FC6F-13F0-39CF-FAC84099F52C}"/>
              </a:ext>
            </a:extLst>
          </p:cNvPr>
          <p:cNvSpPr txBox="1"/>
          <p:nvPr/>
        </p:nvSpPr>
        <p:spPr>
          <a:xfrm>
            <a:off x="3325645" y="63182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sz="1800" kern="1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PMingLiU" panose="02020500000000000000" pitchFamily="18" charset="-120"/>
                <a:cs typeface="Times New Roman" panose="02020603050405020304" pitchFamily="18" charset="0"/>
              </a:rPr>
              <a:t>NP</a:t>
            </a:r>
          </a:p>
        </p:txBody>
      </p:sp>
      <p:pic>
        <p:nvPicPr>
          <p:cNvPr id="11" name="Picture 10" descr="A close-up of a microscope&#10;&#10;Description automatically generated">
            <a:extLst>
              <a:ext uri="{FF2B5EF4-FFF2-40B4-BE49-F238E27FC236}">
                <a16:creationId xmlns:a16="http://schemas.microsoft.com/office/drawing/2014/main" id="{D0933A68-9208-5468-F7FD-9F559AEDCFC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726"/>
          <a:stretch/>
        </p:blipFill>
        <p:spPr>
          <a:xfrm>
            <a:off x="365759" y="3474721"/>
            <a:ext cx="2591064" cy="236873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0B09673-47BA-597B-1B9B-77081289497B}"/>
              </a:ext>
            </a:extLst>
          </p:cNvPr>
          <p:cNvSpPr txBox="1"/>
          <p:nvPr/>
        </p:nvSpPr>
        <p:spPr>
          <a:xfrm>
            <a:off x="78748" y="3459141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03FA15-43B3-1615-1491-723FBE4369D9}"/>
              </a:ext>
            </a:extLst>
          </p:cNvPr>
          <p:cNvSpPr txBox="1"/>
          <p:nvPr/>
        </p:nvSpPr>
        <p:spPr>
          <a:xfrm>
            <a:off x="374468" y="3483428"/>
            <a:ext cx="457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L6</a:t>
            </a:r>
          </a:p>
        </p:txBody>
      </p:sp>
    </p:spTree>
    <p:extLst>
      <p:ext uri="{BB962C8B-B14F-4D97-AF65-F5344CB8AC3E}">
        <p14:creationId xmlns:p14="http://schemas.microsoft.com/office/powerpoint/2010/main" val="16154697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426BB96-B9D4-9681-526B-90BCD7E82223}"/>
              </a:ext>
            </a:extLst>
          </p:cNvPr>
          <p:cNvSpPr txBox="1"/>
          <p:nvPr/>
        </p:nvSpPr>
        <p:spPr>
          <a:xfrm>
            <a:off x="70338" y="124126"/>
            <a:ext cx="2568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3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5C5012F-27FA-1F64-015E-D8513F1AB8B5}"/>
              </a:ext>
            </a:extLst>
          </p:cNvPr>
          <p:cNvSpPr txBox="1"/>
          <p:nvPr/>
        </p:nvSpPr>
        <p:spPr>
          <a:xfrm>
            <a:off x="157770" y="3297238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C</a:t>
            </a:r>
          </a:p>
        </p:txBody>
      </p:sp>
      <p:pic>
        <p:nvPicPr>
          <p:cNvPr id="21" name="Picture 20" descr="A graph of a graph with numbers and letters&#10;&#10;Description automatically generated with medium confidence">
            <a:extLst>
              <a:ext uri="{FF2B5EF4-FFF2-40B4-BE49-F238E27FC236}">
                <a16:creationId xmlns:a16="http://schemas.microsoft.com/office/drawing/2014/main" id="{AE4079D1-E14E-8543-C21B-EC076D08B7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7804"/>
          <a:stretch/>
        </p:blipFill>
        <p:spPr>
          <a:xfrm>
            <a:off x="3789363" y="631825"/>
            <a:ext cx="2852375" cy="2629775"/>
          </a:xfrm>
          <a:prstGeom prst="rect">
            <a:avLst/>
          </a:prstGeom>
        </p:spPr>
      </p:pic>
      <p:pic>
        <p:nvPicPr>
          <p:cNvPr id="27" name="Picture 26" descr="A graph with red dots&#10;&#10;Description automatically generated">
            <a:extLst>
              <a:ext uri="{FF2B5EF4-FFF2-40B4-BE49-F238E27FC236}">
                <a16:creationId xmlns:a16="http://schemas.microsoft.com/office/drawing/2014/main" id="{5C025D30-F00D-9FE7-5BEF-7968729239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4620"/>
          <a:stretch/>
        </p:blipFill>
        <p:spPr>
          <a:xfrm>
            <a:off x="368300" y="3297238"/>
            <a:ext cx="3307287" cy="2757573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E7D685A5-057B-FFA3-FDAA-2442E6FA45CA}"/>
              </a:ext>
            </a:extLst>
          </p:cNvPr>
          <p:cNvSpPr txBox="1"/>
          <p:nvPr/>
        </p:nvSpPr>
        <p:spPr>
          <a:xfrm>
            <a:off x="157770" y="631825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9A50A9AE-3ABC-9268-E46D-C955FF76F2D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241" t="7093" b="6608"/>
          <a:stretch/>
        </p:blipFill>
        <p:spPr>
          <a:xfrm>
            <a:off x="368300" y="1099825"/>
            <a:ext cx="3279258" cy="194577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FED58CA-D864-9A57-7A23-4D27CE97D630}"/>
              </a:ext>
            </a:extLst>
          </p:cNvPr>
          <p:cNvSpPr txBox="1"/>
          <p:nvPr/>
        </p:nvSpPr>
        <p:spPr>
          <a:xfrm>
            <a:off x="3497595" y="631825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82F177E-94F3-F110-0868-DC53E559DAF7}"/>
              </a:ext>
            </a:extLst>
          </p:cNvPr>
          <p:cNvSpPr txBox="1"/>
          <p:nvPr/>
        </p:nvSpPr>
        <p:spPr>
          <a:xfrm>
            <a:off x="368300" y="6323161"/>
            <a:ext cx="6264275" cy="33387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/>
              <a:t>Supplementary figure 3. SARS-CoV-2 activates inflammatory macrophages.</a:t>
            </a:r>
            <a:r>
              <a:rPr lang="en-US" dirty="0"/>
              <a:t> </a:t>
            </a:r>
            <a:r>
              <a:rPr lang="en-US" b="1" dirty="0"/>
              <a:t>(A) </a:t>
            </a:r>
            <a:r>
              <a:rPr lang="en-US" dirty="0"/>
              <a:t>Scheme of the SARS-CoV-2 infection on the isolated immune cells from the vascular immune organoids (VIOs). </a:t>
            </a:r>
            <a:r>
              <a:rPr lang="en-US" b="1" dirty="0"/>
              <a:t>(B) </a:t>
            </a:r>
            <a:r>
              <a:rPr lang="en-US" dirty="0"/>
              <a:t>Volcano plot , </a:t>
            </a:r>
            <a:r>
              <a:rPr lang="en-US" b="1" dirty="0"/>
              <a:t>(C) </a:t>
            </a:r>
            <a:r>
              <a:rPr lang="en-US" dirty="0"/>
              <a:t>Gene set enrichment analysis (GSEA), </a:t>
            </a:r>
            <a:r>
              <a:rPr lang="en-US" b="1" dirty="0"/>
              <a:t>(D) </a:t>
            </a:r>
            <a:r>
              <a:rPr lang="en-US" dirty="0"/>
              <a:t>and KEGG pathway analysis of the integrated VIO and isolated immune cells bulk </a:t>
            </a:r>
            <a:r>
              <a:rPr lang="en-US" dirty="0" err="1"/>
              <a:t>RNAseq</a:t>
            </a:r>
            <a:r>
              <a:rPr lang="en-US" dirty="0"/>
              <a:t> data. 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8F665493-2158-B54B-A0F8-FC31EAF7018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4673"/>
          <a:stretch/>
        </p:blipFill>
        <p:spPr>
          <a:xfrm>
            <a:off x="3830595" y="3297238"/>
            <a:ext cx="2801980" cy="2671032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719507EE-CA83-1652-1061-7F7C1364E02B}"/>
              </a:ext>
            </a:extLst>
          </p:cNvPr>
          <p:cNvSpPr txBox="1"/>
          <p:nvPr/>
        </p:nvSpPr>
        <p:spPr>
          <a:xfrm>
            <a:off x="3695922" y="3297238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9352083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A4E5CE9-5089-9271-119B-C4B1D2D60732}"/>
              </a:ext>
            </a:extLst>
          </p:cNvPr>
          <p:cNvSpPr txBox="1"/>
          <p:nvPr/>
        </p:nvSpPr>
        <p:spPr>
          <a:xfrm>
            <a:off x="70338" y="124126"/>
            <a:ext cx="2568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ry Figure 4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8CB7DEF-7021-80D5-A0D5-2E2695DFD214}"/>
              </a:ext>
            </a:extLst>
          </p:cNvPr>
          <p:cNvSpPr txBox="1"/>
          <p:nvPr/>
        </p:nvSpPr>
        <p:spPr>
          <a:xfrm>
            <a:off x="157770" y="609913"/>
            <a:ext cx="210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/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0656A93-1BCA-2ED8-461C-33D4025A9225}"/>
              </a:ext>
            </a:extLst>
          </p:cNvPr>
          <p:cNvSpPr txBox="1"/>
          <p:nvPr/>
        </p:nvSpPr>
        <p:spPr>
          <a:xfrm>
            <a:off x="368300" y="6738086"/>
            <a:ext cx="6377353" cy="27847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b="1" dirty="0"/>
              <a:t>Supplementary figure 4. Integrated analysis demonstrate mostly macrophage specific response to SARS-CoV-2 (A) </a:t>
            </a:r>
            <a:r>
              <a:rPr lang="en-US" dirty="0"/>
              <a:t>Batch-specific expression of top 30 differential expressed genes from the integrated analysis. “Cells” are the two batches </a:t>
            </a:r>
            <a:r>
              <a:rPr lang="en-US"/>
              <a:t>of isolated macrophages</a:t>
            </a:r>
            <a:r>
              <a:rPr lang="en-US" dirty="0"/>
              <a:t>. ”VIO_1” and “VIO_2” are two batches of VIO.</a:t>
            </a:r>
          </a:p>
        </p:txBody>
      </p:sp>
      <p:pic>
        <p:nvPicPr>
          <p:cNvPr id="7" name="Picture 6" descr="A chart of data on a white background&#10;&#10;Description automatically generated">
            <a:extLst>
              <a:ext uri="{FF2B5EF4-FFF2-40B4-BE49-F238E27FC236}">
                <a16:creationId xmlns:a16="http://schemas.microsoft.com/office/drawing/2014/main" id="{DAB0645D-436C-D3E0-95BC-5E3D3CAB1A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8300" y="631825"/>
            <a:ext cx="6264275" cy="6080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9014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24</TotalTime>
  <Words>437</Words>
  <Application>Microsoft Macintosh PowerPoint</Application>
  <PresentationFormat>A4 Paper (210x297 mm)</PresentationFormat>
  <Paragraphs>42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Alex To</dc:creator>
  <cp:lastModifiedBy>Alex To</cp:lastModifiedBy>
  <cp:revision>8</cp:revision>
  <cp:lastPrinted>2023-12-05T09:20:00Z</cp:lastPrinted>
  <dcterms:created xsi:type="dcterms:W3CDTF">2023-12-04T08:25:07Z</dcterms:created>
  <dcterms:modified xsi:type="dcterms:W3CDTF">2024-03-06T11:33:42Z</dcterms:modified>
</cp:coreProperties>
</file>